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notesMasterIdLst>
    <p:notesMasterId r:id="rId5"/>
  </p:notesMasterIdLst>
  <p:sldIdLst>
    <p:sldId id="325" r:id="rId2"/>
    <p:sldId id="362" r:id="rId3"/>
    <p:sldId id="327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8CDF"/>
    <a:srgbClr val="16A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749" autoAdjust="0"/>
    <p:restoredTop sz="88454" autoAdjust="0"/>
  </p:normalViewPr>
  <p:slideViewPr>
    <p:cSldViewPr>
      <p:cViewPr varScale="1">
        <p:scale>
          <a:sx n="85" d="100"/>
          <a:sy n="85" d="100"/>
        </p:scale>
        <p:origin x="2838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2FAFD0-EF8C-554B-B034-4442DE591FA0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B1FB10-D472-764B-87F9-C134BDEA3E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183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4337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408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8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8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48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8122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0949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935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536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1372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46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7" y="36408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8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1396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8140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1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433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7" Type="http://schemas.microsoft.com/office/2007/relationships/hdphoto" Target="../media/hdphoto5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microsoft.com/office/2007/relationships/hdphoto" Target="../media/hdphoto4.wdp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4288B6DE-26CB-3D72-7A88-BB2434A3E97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12097"/>
          <a:stretch/>
        </p:blipFill>
        <p:spPr bwMode="auto">
          <a:xfrm>
            <a:off x="1791695" y="1032843"/>
            <a:ext cx="2789189" cy="198119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88D09FB-6156-F0BD-4913-22D0CB30F1BB}"/>
              </a:ext>
            </a:extLst>
          </p:cNvPr>
          <p:cNvSpPr txBox="1"/>
          <p:nvPr/>
        </p:nvSpPr>
        <p:spPr>
          <a:xfrm>
            <a:off x="4539835" y="2023442"/>
            <a:ext cx="9783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b="1" dirty="0" err="1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T172</a:t>
            </a:r>
          </a:p>
        </p:txBody>
      </p: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10EC31CE-EF3F-F512-019E-E511B294CCC7}"/>
              </a:ext>
            </a:extLst>
          </p:cNvPr>
          <p:cNvCxnSpPr>
            <a:cxnSpLocks/>
          </p:cNvCxnSpPr>
          <p:nvPr/>
        </p:nvCxnSpPr>
        <p:spPr>
          <a:xfrm flipH="1">
            <a:off x="4322441" y="2253701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" name="Group 5">
            <a:extLst>
              <a:ext uri="{FF2B5EF4-FFF2-40B4-BE49-F238E27FC236}">
                <a16:creationId xmlns:a16="http://schemas.microsoft.com/office/drawing/2014/main" id="{2FA80023-C9B2-18B2-2333-6D528A449BD6}"/>
              </a:ext>
            </a:extLst>
          </p:cNvPr>
          <p:cNvGrpSpPr/>
          <p:nvPr/>
        </p:nvGrpSpPr>
        <p:grpSpPr>
          <a:xfrm>
            <a:off x="990600" y="1337643"/>
            <a:ext cx="660609" cy="1676400"/>
            <a:chOff x="970699" y="3619418"/>
            <a:chExt cx="660609" cy="1676400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F1AA855-F866-F6EA-2783-8D5847E01BBA}"/>
                </a:ext>
              </a:extLst>
            </p:cNvPr>
            <p:cNvSpPr txBox="1"/>
            <p:nvPr/>
          </p:nvSpPr>
          <p:spPr>
            <a:xfrm>
              <a:off x="970699" y="3619418"/>
              <a:ext cx="5834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355B4456-D608-FD35-2A10-B48DF4953F80}"/>
                </a:ext>
              </a:extLst>
            </p:cNvPr>
            <p:cNvCxnSpPr>
              <a:cxnSpLocks/>
            </p:cNvCxnSpPr>
            <p:nvPr/>
          </p:nvCxnSpPr>
          <p:spPr>
            <a:xfrm>
              <a:off x="1467222" y="373942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8E55BEA-2864-9120-357F-94C845CDF486}"/>
                </a:ext>
              </a:extLst>
            </p:cNvPr>
            <p:cNvSpPr txBox="1"/>
            <p:nvPr/>
          </p:nvSpPr>
          <p:spPr>
            <a:xfrm>
              <a:off x="970699" y="3848018"/>
              <a:ext cx="5834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BB156C66-86C8-E70C-7667-74E47E0669C1}"/>
                </a:ext>
              </a:extLst>
            </p:cNvPr>
            <p:cNvCxnSpPr>
              <a:cxnSpLocks/>
            </p:cNvCxnSpPr>
            <p:nvPr/>
          </p:nvCxnSpPr>
          <p:spPr>
            <a:xfrm>
              <a:off x="1467222" y="396802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93F025D-ABA8-D35F-5D79-BE13E6877CC2}"/>
                </a:ext>
              </a:extLst>
            </p:cNvPr>
            <p:cNvSpPr txBox="1"/>
            <p:nvPr/>
          </p:nvSpPr>
          <p:spPr>
            <a:xfrm>
              <a:off x="971623" y="4051756"/>
              <a:ext cx="5825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12E22DA-FAAE-CCB4-3CBB-7B58AE43697A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17176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B80F519-022F-8AA6-5E91-69B19E236073}"/>
                </a:ext>
              </a:extLst>
            </p:cNvPr>
            <p:cNvSpPr txBox="1"/>
            <p:nvPr/>
          </p:nvSpPr>
          <p:spPr>
            <a:xfrm>
              <a:off x="1020007" y="42421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B9BAD51C-5D2D-3D6E-EA6A-D5C7109D8228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3621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F9E2F9F-B889-3E78-2420-48D767C33D5A}"/>
                </a:ext>
              </a:extLst>
            </p:cNvPr>
            <p:cNvSpPr txBox="1"/>
            <p:nvPr/>
          </p:nvSpPr>
          <p:spPr>
            <a:xfrm>
              <a:off x="1020007" y="4531416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A39A5229-B8A9-675C-7A0D-9AD0D929A8FF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65142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7CEA38B-6A91-2458-83C9-5C8BB55B1156}"/>
                </a:ext>
              </a:extLst>
            </p:cNvPr>
            <p:cNvSpPr txBox="1"/>
            <p:nvPr/>
          </p:nvSpPr>
          <p:spPr>
            <a:xfrm>
              <a:off x="1020007" y="46993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0D0B52F7-9ECD-B22F-351D-7ADB1B454C8C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8193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37432E2-7914-CE51-3F10-580D505EE1B5}"/>
                </a:ext>
              </a:extLst>
            </p:cNvPr>
            <p:cNvSpPr txBox="1"/>
            <p:nvPr/>
          </p:nvSpPr>
          <p:spPr>
            <a:xfrm>
              <a:off x="1020007" y="49279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CD387F41-E261-DD6E-8D65-78371449E356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503569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89959D3-1145-2624-546D-159990B6CEF9}"/>
                </a:ext>
              </a:extLst>
            </p:cNvPr>
            <p:cNvSpPr txBox="1"/>
            <p:nvPr/>
          </p:nvSpPr>
          <p:spPr>
            <a:xfrm>
              <a:off x="1020007" y="50803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D96A938F-8B86-A05B-B816-F76D75775A11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52003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84" name="Picture 2">
            <a:extLst>
              <a:ext uri="{FF2B5EF4-FFF2-40B4-BE49-F238E27FC236}">
                <a16:creationId xmlns:a16="http://schemas.microsoft.com/office/drawing/2014/main" id="{27F6F320-B729-22D1-D7FE-1568C19BDDB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446" b="12383"/>
          <a:stretch/>
        </p:blipFill>
        <p:spPr bwMode="auto">
          <a:xfrm>
            <a:off x="1791695" y="3127367"/>
            <a:ext cx="2789189" cy="20445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85" name="TextBox 84">
            <a:extLst>
              <a:ext uri="{FF2B5EF4-FFF2-40B4-BE49-F238E27FC236}">
                <a16:creationId xmlns:a16="http://schemas.microsoft.com/office/drawing/2014/main" id="{2CA9F9FF-4139-5F2D-62C2-F9BCEA691DAD}"/>
              </a:ext>
            </a:extLst>
          </p:cNvPr>
          <p:cNvSpPr txBox="1"/>
          <p:nvPr/>
        </p:nvSpPr>
        <p:spPr>
          <a:xfrm>
            <a:off x="4672062" y="3969448"/>
            <a:ext cx="9783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r>
              <a:rPr lang="en-US" sz="800" b="1" dirty="0" err="1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140D4AB9-50C3-DF1B-1874-4001103871CD}"/>
              </a:ext>
            </a:extLst>
          </p:cNvPr>
          <p:cNvCxnSpPr>
            <a:cxnSpLocks/>
          </p:cNvCxnSpPr>
          <p:nvPr/>
        </p:nvCxnSpPr>
        <p:spPr>
          <a:xfrm flipH="1">
            <a:off x="4488746" y="4217685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>
            <a:extLst>
              <a:ext uri="{FF2B5EF4-FFF2-40B4-BE49-F238E27FC236}">
                <a16:creationId xmlns:a16="http://schemas.microsoft.com/office/drawing/2014/main" id="{67E76C66-20C1-ECBB-4366-81E0ED39A64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-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748" r="13351" b="59287"/>
          <a:stretch/>
        </p:blipFill>
        <p:spPr bwMode="auto">
          <a:xfrm flipH="1">
            <a:off x="1828800" y="5257800"/>
            <a:ext cx="2752084" cy="20055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754A29E9-094B-722F-9FC1-92B7200D203C}"/>
              </a:ext>
            </a:extLst>
          </p:cNvPr>
          <p:cNvSpPr txBox="1"/>
          <p:nvPr/>
        </p:nvSpPr>
        <p:spPr>
          <a:xfrm>
            <a:off x="4717113" y="5478039"/>
            <a:ext cx="9783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ACC S79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DC9F135A-5DA9-D413-6025-1C247D37DCDA}"/>
              </a:ext>
            </a:extLst>
          </p:cNvPr>
          <p:cNvCxnSpPr>
            <a:cxnSpLocks/>
          </p:cNvCxnSpPr>
          <p:nvPr/>
        </p:nvCxnSpPr>
        <p:spPr>
          <a:xfrm flipH="1">
            <a:off x="4501092" y="5715000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0" name="Group 49">
            <a:extLst>
              <a:ext uri="{FF2B5EF4-FFF2-40B4-BE49-F238E27FC236}">
                <a16:creationId xmlns:a16="http://schemas.microsoft.com/office/drawing/2014/main" id="{B01C6A46-6046-EB2A-774D-3C63C1A585D9}"/>
              </a:ext>
            </a:extLst>
          </p:cNvPr>
          <p:cNvGrpSpPr/>
          <p:nvPr/>
        </p:nvGrpSpPr>
        <p:grpSpPr>
          <a:xfrm>
            <a:off x="1024073" y="3247295"/>
            <a:ext cx="660609" cy="1676400"/>
            <a:chOff x="970699" y="3619418"/>
            <a:chExt cx="660609" cy="1676400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43CF55C2-8101-931E-CB4F-19A470F821AA}"/>
                </a:ext>
              </a:extLst>
            </p:cNvPr>
            <p:cNvSpPr txBox="1"/>
            <p:nvPr/>
          </p:nvSpPr>
          <p:spPr>
            <a:xfrm>
              <a:off x="970699" y="3619418"/>
              <a:ext cx="5834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410B9DC3-E51E-14F4-59DF-C2F7943B2584}"/>
                </a:ext>
              </a:extLst>
            </p:cNvPr>
            <p:cNvCxnSpPr>
              <a:cxnSpLocks/>
            </p:cNvCxnSpPr>
            <p:nvPr/>
          </p:nvCxnSpPr>
          <p:spPr>
            <a:xfrm>
              <a:off x="1467222" y="373942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0CAB4C41-FF53-D456-E726-485701D823E5}"/>
                </a:ext>
              </a:extLst>
            </p:cNvPr>
            <p:cNvSpPr txBox="1"/>
            <p:nvPr/>
          </p:nvSpPr>
          <p:spPr>
            <a:xfrm>
              <a:off x="970699" y="3848018"/>
              <a:ext cx="5834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94DE19AB-0C82-167C-67D3-5DB9697AD782}"/>
                </a:ext>
              </a:extLst>
            </p:cNvPr>
            <p:cNvCxnSpPr>
              <a:cxnSpLocks/>
            </p:cNvCxnSpPr>
            <p:nvPr/>
          </p:nvCxnSpPr>
          <p:spPr>
            <a:xfrm>
              <a:off x="1467222" y="396802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82446C71-9B99-6063-FC46-78807CB5BCB3}"/>
                </a:ext>
              </a:extLst>
            </p:cNvPr>
            <p:cNvSpPr txBox="1"/>
            <p:nvPr/>
          </p:nvSpPr>
          <p:spPr>
            <a:xfrm>
              <a:off x="971623" y="4051756"/>
              <a:ext cx="5825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AE45C8A7-AEC0-61CA-3D29-5CD734230764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17176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94758146-F19A-2249-D9BF-9AE704996D53}"/>
                </a:ext>
              </a:extLst>
            </p:cNvPr>
            <p:cNvSpPr txBox="1"/>
            <p:nvPr/>
          </p:nvSpPr>
          <p:spPr>
            <a:xfrm>
              <a:off x="1020007" y="42421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C4ED8C56-61E1-1275-1772-8054C8FA90A7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3621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40CC15A4-8D80-DBEC-935C-DD9F1F96CB9A}"/>
                </a:ext>
              </a:extLst>
            </p:cNvPr>
            <p:cNvSpPr txBox="1"/>
            <p:nvPr/>
          </p:nvSpPr>
          <p:spPr>
            <a:xfrm>
              <a:off x="1020007" y="4531416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F8CA68D3-3886-FAA3-B248-27120C619800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65142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CF460311-C2EC-2B8E-B592-6ECADB3116E3}"/>
                </a:ext>
              </a:extLst>
            </p:cNvPr>
            <p:cNvSpPr txBox="1"/>
            <p:nvPr/>
          </p:nvSpPr>
          <p:spPr>
            <a:xfrm>
              <a:off x="1020007" y="46993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09FD2162-36F8-3286-3DF1-58621F2C3101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8193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8CCAF8A0-F493-1B65-BCC7-88E4D054BEC5}"/>
                </a:ext>
              </a:extLst>
            </p:cNvPr>
            <p:cNvSpPr txBox="1"/>
            <p:nvPr/>
          </p:nvSpPr>
          <p:spPr>
            <a:xfrm>
              <a:off x="1020007" y="49279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7CB13E4E-33AF-5339-BF48-1369C33395D1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503569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53E74EF9-1F70-7CCD-0312-53D82257350D}"/>
                </a:ext>
              </a:extLst>
            </p:cNvPr>
            <p:cNvSpPr txBox="1"/>
            <p:nvPr/>
          </p:nvSpPr>
          <p:spPr>
            <a:xfrm>
              <a:off x="1020007" y="50803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58303D2E-BEBD-3C49-67E3-16F670E8BA7B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52003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7" name="Group 66">
            <a:extLst>
              <a:ext uri="{FF2B5EF4-FFF2-40B4-BE49-F238E27FC236}">
                <a16:creationId xmlns:a16="http://schemas.microsoft.com/office/drawing/2014/main" id="{1348DD2A-B710-8985-95FC-0D73CCD21180}"/>
              </a:ext>
            </a:extLst>
          </p:cNvPr>
          <p:cNvGrpSpPr/>
          <p:nvPr/>
        </p:nvGrpSpPr>
        <p:grpSpPr>
          <a:xfrm>
            <a:off x="1075478" y="5632829"/>
            <a:ext cx="660609" cy="1676400"/>
            <a:chOff x="970699" y="3619418"/>
            <a:chExt cx="660609" cy="1676400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39E81126-807B-6DFD-6C30-2A3B21DF8455}"/>
                </a:ext>
              </a:extLst>
            </p:cNvPr>
            <p:cNvSpPr txBox="1"/>
            <p:nvPr/>
          </p:nvSpPr>
          <p:spPr>
            <a:xfrm>
              <a:off x="970699" y="3619418"/>
              <a:ext cx="5834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7D9568CB-389C-8141-4F15-55C241D1AF75}"/>
                </a:ext>
              </a:extLst>
            </p:cNvPr>
            <p:cNvCxnSpPr>
              <a:cxnSpLocks/>
            </p:cNvCxnSpPr>
            <p:nvPr/>
          </p:nvCxnSpPr>
          <p:spPr>
            <a:xfrm>
              <a:off x="1467222" y="373942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C98C3D46-DB71-F3F5-4DC8-0B1316F8638B}"/>
                </a:ext>
              </a:extLst>
            </p:cNvPr>
            <p:cNvSpPr txBox="1"/>
            <p:nvPr/>
          </p:nvSpPr>
          <p:spPr>
            <a:xfrm>
              <a:off x="970699" y="3848018"/>
              <a:ext cx="5834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8FDAE1F7-ACD4-2DC9-ED81-9B3C2619A658}"/>
                </a:ext>
              </a:extLst>
            </p:cNvPr>
            <p:cNvCxnSpPr>
              <a:cxnSpLocks/>
            </p:cNvCxnSpPr>
            <p:nvPr/>
          </p:nvCxnSpPr>
          <p:spPr>
            <a:xfrm>
              <a:off x="1467222" y="396802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1DB09061-1B45-6B69-565F-BB6F9811314C}"/>
                </a:ext>
              </a:extLst>
            </p:cNvPr>
            <p:cNvSpPr txBox="1"/>
            <p:nvPr/>
          </p:nvSpPr>
          <p:spPr>
            <a:xfrm>
              <a:off x="971623" y="4051756"/>
              <a:ext cx="5825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69343EA9-F0CC-C995-BED8-14F7624143B4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17176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7712B83D-D1D6-AFBC-A329-70A4490296BB}"/>
                </a:ext>
              </a:extLst>
            </p:cNvPr>
            <p:cNvSpPr txBox="1"/>
            <p:nvPr/>
          </p:nvSpPr>
          <p:spPr>
            <a:xfrm>
              <a:off x="1020007" y="42421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7FFC310E-9A94-AF02-117C-FAF2C6182B66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3621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52EBF914-8A2A-E69C-34B0-D66CC6243E57}"/>
                </a:ext>
              </a:extLst>
            </p:cNvPr>
            <p:cNvSpPr txBox="1"/>
            <p:nvPr/>
          </p:nvSpPr>
          <p:spPr>
            <a:xfrm>
              <a:off x="1020007" y="4531416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151A5C84-A7ED-551F-679D-3093F2BA96AB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65142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89D83CD3-2C58-03AA-203B-7BD312E3F739}"/>
                </a:ext>
              </a:extLst>
            </p:cNvPr>
            <p:cNvSpPr txBox="1"/>
            <p:nvPr/>
          </p:nvSpPr>
          <p:spPr>
            <a:xfrm>
              <a:off x="1020007" y="46993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ACB02087-3019-BDAB-CD0C-F1F5A51B1B28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8193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D92A8A10-9506-62CB-A497-43019D4CD9A4}"/>
                </a:ext>
              </a:extLst>
            </p:cNvPr>
            <p:cNvSpPr txBox="1"/>
            <p:nvPr/>
          </p:nvSpPr>
          <p:spPr>
            <a:xfrm>
              <a:off x="1020007" y="49279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69E14A4D-AE6A-41A5-4B9D-3FB3E77ED357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503569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B1A594DD-6C15-1FAC-F5AF-1FE142E8954B}"/>
                </a:ext>
              </a:extLst>
            </p:cNvPr>
            <p:cNvSpPr txBox="1"/>
            <p:nvPr/>
          </p:nvSpPr>
          <p:spPr>
            <a:xfrm>
              <a:off x="1020007" y="50803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CCE55C64-4BF3-C0EF-769E-40F75B755766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52003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73425947-B36B-95D7-DDE1-5DE03826F84F}"/>
              </a:ext>
            </a:extLst>
          </p:cNvPr>
          <p:cNvSpPr txBox="1"/>
          <p:nvPr/>
        </p:nvSpPr>
        <p:spPr>
          <a:xfrm>
            <a:off x="152400" y="7646678"/>
            <a:ext cx="640079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/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7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iginal uncropped Western blot images for Fig. 7a.</a:t>
            </a:r>
            <a:endParaRPr lang="en-US" sz="1200" dirty="0">
              <a:effectLst/>
              <a:latin typeface="Aptos" panose="020B00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8545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1DA6824-3DF9-086E-87B9-8E2C3363FF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0" y="152400"/>
            <a:ext cx="4770336" cy="79310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6608709-5CD7-6279-9335-D43BE8FAA15E}"/>
              </a:ext>
            </a:extLst>
          </p:cNvPr>
          <p:cNvSpPr txBox="1"/>
          <p:nvPr/>
        </p:nvSpPr>
        <p:spPr>
          <a:xfrm>
            <a:off x="228600" y="8229600"/>
            <a:ext cx="640079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 (continued)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iginal uncropped Western blot images for Fig. 7a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effectLst/>
              <a:latin typeface="Aptos" panose="020B00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en-US" sz="1200" b="0" i="0" u="none" strike="noStrike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98928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">
            <a:extLst>
              <a:ext uri="{FF2B5EF4-FFF2-40B4-BE49-F238E27FC236}">
                <a16:creationId xmlns:a16="http://schemas.microsoft.com/office/drawing/2014/main" id="{8DD83CD2-3DF5-7D7D-A24F-4E10B0183CC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2000" r="3127"/>
          <a:stretch/>
        </p:blipFill>
        <p:spPr bwMode="auto">
          <a:xfrm>
            <a:off x="1905000" y="381000"/>
            <a:ext cx="2789189" cy="209642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25" name="Picture 3">
            <a:extLst>
              <a:ext uri="{FF2B5EF4-FFF2-40B4-BE49-F238E27FC236}">
                <a16:creationId xmlns:a16="http://schemas.microsoft.com/office/drawing/2014/main" id="{47AAE6F5-6855-7F44-B3E8-8258BCAD2C4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1462" r="4828"/>
          <a:stretch/>
        </p:blipFill>
        <p:spPr bwMode="auto">
          <a:xfrm>
            <a:off x="1875034" y="2680154"/>
            <a:ext cx="2862295" cy="209642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7B1A1618-B886-5695-9F7F-1D70FD9DE14C}"/>
              </a:ext>
            </a:extLst>
          </p:cNvPr>
          <p:cNvSpPr txBox="1"/>
          <p:nvPr/>
        </p:nvSpPr>
        <p:spPr>
          <a:xfrm>
            <a:off x="4808853" y="1600200"/>
            <a:ext cx="9783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IkB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A56B8F3A-B916-D1F5-623F-EA3E3170D4F5}"/>
              </a:ext>
            </a:extLst>
          </p:cNvPr>
          <p:cNvCxnSpPr>
            <a:cxnSpLocks/>
          </p:cNvCxnSpPr>
          <p:nvPr/>
        </p:nvCxnSpPr>
        <p:spPr>
          <a:xfrm flipH="1">
            <a:off x="4591459" y="1830459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33F8BB64-5006-12DD-0D55-3FAE1A084D66}"/>
              </a:ext>
            </a:extLst>
          </p:cNvPr>
          <p:cNvSpPr txBox="1"/>
          <p:nvPr/>
        </p:nvSpPr>
        <p:spPr>
          <a:xfrm>
            <a:off x="4849950" y="3581400"/>
            <a:ext cx="9783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E8009298-319E-DEA3-6AE5-3796977CC74C}"/>
              </a:ext>
            </a:extLst>
          </p:cNvPr>
          <p:cNvCxnSpPr>
            <a:cxnSpLocks/>
          </p:cNvCxnSpPr>
          <p:nvPr/>
        </p:nvCxnSpPr>
        <p:spPr>
          <a:xfrm flipH="1">
            <a:off x="4632556" y="3811659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4" name="Picture 3">
            <a:extLst>
              <a:ext uri="{FF2B5EF4-FFF2-40B4-BE49-F238E27FC236}">
                <a16:creationId xmlns:a16="http://schemas.microsoft.com/office/drawing/2014/main" id="{542C709E-2AA5-4308-E7C4-9F5DC4C5F97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5371" r="3035" b="23679"/>
          <a:stretch/>
        </p:blipFill>
        <p:spPr bwMode="auto">
          <a:xfrm>
            <a:off x="1846744" y="4971826"/>
            <a:ext cx="2862295" cy="154074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6A88855B-9DCC-9728-9402-A3C0425E29E2}"/>
              </a:ext>
            </a:extLst>
          </p:cNvPr>
          <p:cNvSpPr txBox="1"/>
          <p:nvPr/>
        </p:nvSpPr>
        <p:spPr>
          <a:xfrm>
            <a:off x="4851743" y="5531079"/>
            <a:ext cx="9783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</a:p>
        </p:txBody>
      </p: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E93F0371-32F6-C11D-AF57-7AA187345445}"/>
              </a:ext>
            </a:extLst>
          </p:cNvPr>
          <p:cNvCxnSpPr>
            <a:cxnSpLocks/>
          </p:cNvCxnSpPr>
          <p:nvPr/>
        </p:nvCxnSpPr>
        <p:spPr>
          <a:xfrm flipH="1">
            <a:off x="4634349" y="5761338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" name="Group 7">
            <a:extLst>
              <a:ext uri="{FF2B5EF4-FFF2-40B4-BE49-F238E27FC236}">
                <a16:creationId xmlns:a16="http://schemas.microsoft.com/office/drawing/2014/main" id="{0AEAC626-971E-F8AA-CE80-E17C4E0F696D}"/>
              </a:ext>
            </a:extLst>
          </p:cNvPr>
          <p:cNvGrpSpPr/>
          <p:nvPr/>
        </p:nvGrpSpPr>
        <p:grpSpPr>
          <a:xfrm>
            <a:off x="1187059" y="741489"/>
            <a:ext cx="660609" cy="1676400"/>
            <a:chOff x="970699" y="3619418"/>
            <a:chExt cx="660609" cy="1676400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70F9816-5592-2365-DA3F-DFC8271924D9}"/>
                </a:ext>
              </a:extLst>
            </p:cNvPr>
            <p:cNvSpPr txBox="1"/>
            <p:nvPr/>
          </p:nvSpPr>
          <p:spPr>
            <a:xfrm>
              <a:off x="970699" y="3619418"/>
              <a:ext cx="5834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A441B242-F346-F519-A536-C2F56AB78A32}"/>
                </a:ext>
              </a:extLst>
            </p:cNvPr>
            <p:cNvCxnSpPr>
              <a:cxnSpLocks/>
            </p:cNvCxnSpPr>
            <p:nvPr/>
          </p:nvCxnSpPr>
          <p:spPr>
            <a:xfrm>
              <a:off x="1467222" y="373942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DDA40A7-AD3F-DBFA-4D9B-B95C81A413F9}"/>
                </a:ext>
              </a:extLst>
            </p:cNvPr>
            <p:cNvSpPr txBox="1"/>
            <p:nvPr/>
          </p:nvSpPr>
          <p:spPr>
            <a:xfrm>
              <a:off x="970699" y="3848018"/>
              <a:ext cx="5834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FDAAB4DB-0986-5577-E54C-BD40C2843A34}"/>
                </a:ext>
              </a:extLst>
            </p:cNvPr>
            <p:cNvCxnSpPr>
              <a:cxnSpLocks/>
            </p:cNvCxnSpPr>
            <p:nvPr/>
          </p:nvCxnSpPr>
          <p:spPr>
            <a:xfrm>
              <a:off x="1467222" y="396802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F51D52E-CC0F-85C9-176A-D407A8451BA8}"/>
                </a:ext>
              </a:extLst>
            </p:cNvPr>
            <p:cNvSpPr txBox="1"/>
            <p:nvPr/>
          </p:nvSpPr>
          <p:spPr>
            <a:xfrm>
              <a:off x="971623" y="4051756"/>
              <a:ext cx="5825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23C42A7E-2271-B9C6-1BB0-0A2E74EA24A9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17176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9C1E60C-CEA0-D7F7-3F8F-C88E68773E81}"/>
                </a:ext>
              </a:extLst>
            </p:cNvPr>
            <p:cNvSpPr txBox="1"/>
            <p:nvPr/>
          </p:nvSpPr>
          <p:spPr>
            <a:xfrm>
              <a:off x="1020007" y="42421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5C2ABFA9-85B3-CF7D-22CE-7C5D56D8D6A2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3621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68C8628-4F85-8B0D-D61A-4B34E5BE942C}"/>
                </a:ext>
              </a:extLst>
            </p:cNvPr>
            <p:cNvSpPr txBox="1"/>
            <p:nvPr/>
          </p:nvSpPr>
          <p:spPr>
            <a:xfrm>
              <a:off x="1020007" y="4531416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3432AC9B-5350-ECD5-1833-C695D8C1788D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65142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99E44E8-8D11-3E2B-88AD-C1A616BE9C07}"/>
                </a:ext>
              </a:extLst>
            </p:cNvPr>
            <p:cNvSpPr txBox="1"/>
            <p:nvPr/>
          </p:nvSpPr>
          <p:spPr>
            <a:xfrm>
              <a:off x="1020007" y="46993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0D837E87-1BB2-3EB5-C8FF-D721A335E3A2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8193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697D3A8-427A-E1D4-AEC7-3114211422B1}"/>
                </a:ext>
              </a:extLst>
            </p:cNvPr>
            <p:cNvSpPr txBox="1"/>
            <p:nvPr/>
          </p:nvSpPr>
          <p:spPr>
            <a:xfrm>
              <a:off x="1020007" y="49279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125A0872-8186-2BD2-D778-B40FA8614361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503569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38CEFC9-F084-C1DF-F3A8-A5F3459D9FD7}"/>
                </a:ext>
              </a:extLst>
            </p:cNvPr>
            <p:cNvSpPr txBox="1"/>
            <p:nvPr/>
          </p:nvSpPr>
          <p:spPr>
            <a:xfrm>
              <a:off x="1020007" y="50803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A8A75115-7382-051F-EC6D-6E920E6FF95C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52003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5" name="Group 84">
            <a:extLst>
              <a:ext uri="{FF2B5EF4-FFF2-40B4-BE49-F238E27FC236}">
                <a16:creationId xmlns:a16="http://schemas.microsoft.com/office/drawing/2014/main" id="{5ACD7368-F60E-1F6B-27F7-A09ECB5539C5}"/>
              </a:ext>
            </a:extLst>
          </p:cNvPr>
          <p:cNvGrpSpPr/>
          <p:nvPr/>
        </p:nvGrpSpPr>
        <p:grpSpPr>
          <a:xfrm>
            <a:off x="1148491" y="2943081"/>
            <a:ext cx="660609" cy="1676400"/>
            <a:chOff x="970699" y="3619418"/>
            <a:chExt cx="660609" cy="1676400"/>
          </a:xfrm>
        </p:grpSpPr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BA3DEFE1-2CBA-2630-1915-B7DB5C94B92E}"/>
                </a:ext>
              </a:extLst>
            </p:cNvPr>
            <p:cNvSpPr txBox="1"/>
            <p:nvPr/>
          </p:nvSpPr>
          <p:spPr>
            <a:xfrm>
              <a:off x="970699" y="3619418"/>
              <a:ext cx="5834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841FCAF3-BF19-4CC3-BD40-203690D5B71E}"/>
                </a:ext>
              </a:extLst>
            </p:cNvPr>
            <p:cNvCxnSpPr>
              <a:cxnSpLocks/>
            </p:cNvCxnSpPr>
            <p:nvPr/>
          </p:nvCxnSpPr>
          <p:spPr>
            <a:xfrm>
              <a:off x="1467222" y="373942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6C250C83-1DBD-24A5-5247-EF6E3B8660ED}"/>
                </a:ext>
              </a:extLst>
            </p:cNvPr>
            <p:cNvSpPr txBox="1"/>
            <p:nvPr/>
          </p:nvSpPr>
          <p:spPr>
            <a:xfrm>
              <a:off x="970699" y="3848018"/>
              <a:ext cx="5834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3DCCACAE-21AB-E3DC-3949-70ACBA84E6CC}"/>
                </a:ext>
              </a:extLst>
            </p:cNvPr>
            <p:cNvCxnSpPr>
              <a:cxnSpLocks/>
            </p:cNvCxnSpPr>
            <p:nvPr/>
          </p:nvCxnSpPr>
          <p:spPr>
            <a:xfrm>
              <a:off x="1467222" y="396802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73EC155D-9410-164B-04E0-8020A0CA7EAB}"/>
                </a:ext>
              </a:extLst>
            </p:cNvPr>
            <p:cNvSpPr txBox="1"/>
            <p:nvPr/>
          </p:nvSpPr>
          <p:spPr>
            <a:xfrm>
              <a:off x="971623" y="4051756"/>
              <a:ext cx="5825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F002DD30-216F-568A-2C7D-E53B0175BD3E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17176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D11CB508-A9C1-2CBB-047E-4CA1B615EB60}"/>
                </a:ext>
              </a:extLst>
            </p:cNvPr>
            <p:cNvSpPr txBox="1"/>
            <p:nvPr/>
          </p:nvSpPr>
          <p:spPr>
            <a:xfrm>
              <a:off x="1020007" y="42421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A86BE050-D1B0-F0DC-24DA-B647C72F7661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3621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E8A0549E-56E4-4916-C409-FB99D2588465}"/>
                </a:ext>
              </a:extLst>
            </p:cNvPr>
            <p:cNvSpPr txBox="1"/>
            <p:nvPr/>
          </p:nvSpPr>
          <p:spPr>
            <a:xfrm>
              <a:off x="1020007" y="4531416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7A2D7C45-022F-10C9-9DE3-6018270441C4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65142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B6EFCA7A-62BB-1307-C71B-7E8339D402F6}"/>
                </a:ext>
              </a:extLst>
            </p:cNvPr>
            <p:cNvSpPr txBox="1"/>
            <p:nvPr/>
          </p:nvSpPr>
          <p:spPr>
            <a:xfrm>
              <a:off x="1020007" y="46993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15750412-E80E-EC20-0F11-FE75B474D0D8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8193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F8AD91BE-DC10-2DA4-FB07-BB83A24F71CF}"/>
                </a:ext>
              </a:extLst>
            </p:cNvPr>
            <p:cNvSpPr txBox="1"/>
            <p:nvPr/>
          </p:nvSpPr>
          <p:spPr>
            <a:xfrm>
              <a:off x="1020007" y="49279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4FFE7ACE-9301-680B-384E-A6DBCEE2AE33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503569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D99DF7DB-BB13-9ACD-6C71-7D96FCAAB833}"/>
                </a:ext>
              </a:extLst>
            </p:cNvPr>
            <p:cNvSpPr txBox="1"/>
            <p:nvPr/>
          </p:nvSpPr>
          <p:spPr>
            <a:xfrm>
              <a:off x="1020007" y="50803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BBD8090B-72B5-9C4C-CC4E-FED1F8E1A8B5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52003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CEF3E74A-9FDF-C4D9-2E78-F3555DF96BA4}"/>
              </a:ext>
            </a:extLst>
          </p:cNvPr>
          <p:cNvGrpSpPr/>
          <p:nvPr/>
        </p:nvGrpSpPr>
        <p:grpSpPr>
          <a:xfrm>
            <a:off x="1109923" y="5093539"/>
            <a:ext cx="660609" cy="1295400"/>
            <a:chOff x="970699" y="3619418"/>
            <a:chExt cx="660609" cy="1295400"/>
          </a:xfrm>
        </p:grpSpPr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54B6AD0C-0534-3DF8-4021-F17E0CD6ABD9}"/>
                </a:ext>
              </a:extLst>
            </p:cNvPr>
            <p:cNvSpPr txBox="1"/>
            <p:nvPr/>
          </p:nvSpPr>
          <p:spPr>
            <a:xfrm>
              <a:off x="970699" y="3619418"/>
              <a:ext cx="5834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DCB169D5-129F-E9C9-41C0-197EF2EAEDCF}"/>
                </a:ext>
              </a:extLst>
            </p:cNvPr>
            <p:cNvCxnSpPr>
              <a:cxnSpLocks/>
            </p:cNvCxnSpPr>
            <p:nvPr/>
          </p:nvCxnSpPr>
          <p:spPr>
            <a:xfrm>
              <a:off x="1467222" y="373942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E35FDABB-8DD4-3D30-3EDA-BEE9A367E71F}"/>
                </a:ext>
              </a:extLst>
            </p:cNvPr>
            <p:cNvSpPr txBox="1"/>
            <p:nvPr/>
          </p:nvSpPr>
          <p:spPr>
            <a:xfrm>
              <a:off x="970699" y="3848018"/>
              <a:ext cx="5834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BA392F67-B754-BC3A-4F7F-BB3AA5E6915F}"/>
                </a:ext>
              </a:extLst>
            </p:cNvPr>
            <p:cNvCxnSpPr>
              <a:cxnSpLocks/>
            </p:cNvCxnSpPr>
            <p:nvPr/>
          </p:nvCxnSpPr>
          <p:spPr>
            <a:xfrm>
              <a:off x="1467222" y="396802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CF248417-19D0-05CF-F203-9342FD47F0A4}"/>
                </a:ext>
              </a:extLst>
            </p:cNvPr>
            <p:cNvSpPr txBox="1"/>
            <p:nvPr/>
          </p:nvSpPr>
          <p:spPr>
            <a:xfrm>
              <a:off x="971623" y="4051756"/>
              <a:ext cx="5825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C545456B-2A68-545C-1547-08DDFED9B0C5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17176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B454841E-6CB5-065B-5736-28C07E16D5DF}"/>
                </a:ext>
              </a:extLst>
            </p:cNvPr>
            <p:cNvSpPr txBox="1"/>
            <p:nvPr/>
          </p:nvSpPr>
          <p:spPr>
            <a:xfrm>
              <a:off x="1020007" y="42421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DF84F1D2-8CE5-D24D-8112-6C651B6D9E7B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3621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AAE5268A-6223-1D8E-DEF0-3EC697DC0C83}"/>
                </a:ext>
              </a:extLst>
            </p:cNvPr>
            <p:cNvSpPr txBox="1"/>
            <p:nvPr/>
          </p:nvSpPr>
          <p:spPr>
            <a:xfrm>
              <a:off x="1020007" y="4531416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429D4810-6690-0593-4DB5-063346AFFD5D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651422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DF53DE2D-C664-407C-EA2A-74AA04022BB5}"/>
                </a:ext>
              </a:extLst>
            </p:cNvPr>
            <p:cNvSpPr txBox="1"/>
            <p:nvPr/>
          </p:nvSpPr>
          <p:spPr>
            <a:xfrm>
              <a:off x="1020007" y="4699374"/>
              <a:ext cx="5341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85A4C17F-F05B-B290-E6F9-6C06A5F20C51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819380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427012D6-D2E3-B905-63D0-CBFF9AAA27F4}"/>
              </a:ext>
            </a:extLst>
          </p:cNvPr>
          <p:cNvSpPr txBox="1"/>
          <p:nvPr/>
        </p:nvSpPr>
        <p:spPr>
          <a:xfrm>
            <a:off x="25400" y="7171599"/>
            <a:ext cx="67564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 (continued)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Original uncropped Western blot images for Fig. 7a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effectLst/>
              <a:latin typeface="Aptos" panose="020B00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200" b="0" i="0" u="none" strike="noStrike" baseline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15994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50713</TotalTime>
  <Words>146</Words>
  <Application>Microsoft Office PowerPoint</Application>
  <PresentationFormat>On-screen Show (4:3)</PresentationFormat>
  <Paragraphs>5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rial</vt:lpstr>
      <vt:lpstr>Calibri</vt:lpstr>
      <vt:lpstr>Symbol</vt:lpstr>
      <vt:lpstr>Office Theme</vt:lpstr>
      <vt:lpstr>PowerPoint Presentation</vt:lpstr>
      <vt:lpstr>PowerPoint Presentation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A Trushin</dc:creator>
  <cp:lastModifiedBy>Trushin, Sergey A., Ph.D.</cp:lastModifiedBy>
  <cp:revision>604</cp:revision>
  <cp:lastPrinted>2022-11-09T15:46:24Z</cp:lastPrinted>
  <dcterms:created xsi:type="dcterms:W3CDTF">2020-01-31T17:27:01Z</dcterms:created>
  <dcterms:modified xsi:type="dcterms:W3CDTF">2025-02-12T20:33:16Z</dcterms:modified>
</cp:coreProperties>
</file>